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1F9E9C-6160-4C71-A310-828C7CB8333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E74DFA-CABD-40FC-AB0C-9ACAF4E6DBD9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5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endParaRPr lang="en-US" smtClean="0">
              <a:ea typeface="ＭＳ Ｐゴシック" pitchFamily="34" charset="-128"/>
            </a:endParaRPr>
          </a:p>
        </p:txBody>
      </p:sp>
      <p:sp>
        <p:nvSpPr>
          <p:cNvPr id="1946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7BE4CEFE-00A0-4583-BFBD-C3603327E8C2}" type="slidenum">
              <a:rPr lang="en-GB" smtClean="0">
                <a:latin typeface="Arial" pitchFamily="34" charset="0"/>
                <a:ea typeface="ＭＳ Ｐゴシック" pitchFamily="34" charset="-128"/>
              </a:rPr>
              <a:pPr/>
              <a:t>1</a:t>
            </a:fld>
            <a:endParaRPr lang="en-GB" smtClean="0">
              <a:latin typeface="Arial" pitchFamily="34" charset="0"/>
              <a:ea typeface="ＭＳ Ｐゴシック" pitchFamily="34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F4C14-37DA-428E-A475-A2159A6ED348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8F420-49BC-4CA3-ADD0-08207F1CA7DB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500718" y="404813"/>
          <a:ext cx="6011333" cy="1407321"/>
        </p:xfrm>
        <a:graphic>
          <a:graphicData uri="http://schemas.openxmlformats.org/drawingml/2006/table">
            <a:tbl>
              <a:tblPr/>
              <a:tblGrid>
                <a:gridCol w="1134533"/>
                <a:gridCol w="812800"/>
                <a:gridCol w="812800"/>
                <a:gridCol w="504229"/>
                <a:gridCol w="864096"/>
                <a:gridCol w="1882875"/>
              </a:tblGrid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PROBESET I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ENES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og2 ratio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</a:t>
                      </a: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 value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e name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1042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M2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.1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7.8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.44E-05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issue 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glutaminas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5729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SMR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26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2.95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99E-04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Oncostatin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M receptor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12464_s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N1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.4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4.2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65E-03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Fibronecti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0495_x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N1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.3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2.9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43E-03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bronectin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1719_x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N1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.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2.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81E-03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Fibronecti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6442_x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N1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.3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1.86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33E-03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bronectin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1389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TGA5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2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.4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222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Integrin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Symbol" pitchFamily="18" charset="2"/>
                        </a:rPr>
                        <a:t>a</a:t>
                      </a:r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1945_s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TGB1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5.6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Integrin-</a:t>
                      </a:r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Symbol" pitchFamily="18" charset="2"/>
                        </a:rPr>
                        <a:t>b</a:t>
                      </a:r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049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53678_a_at</a:t>
                      </a: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TGB1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6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5.1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75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Integrin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Symbol" pitchFamily="18" charset="2"/>
                        </a:rPr>
                        <a:t>b</a:t>
                      </a:r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1332" name="Text Box 4"/>
          <p:cNvSpPr txBox="1">
            <a:spLocks noChangeArrowheads="1"/>
          </p:cNvSpPr>
          <p:nvPr/>
        </p:nvSpPr>
        <p:spPr bwMode="auto">
          <a:xfrm>
            <a:off x="0" y="0"/>
            <a:ext cx="245515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/>
              <a:t>Supplementary Table-S3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On-screen Show (4:3)</PresentationFormat>
  <Paragraphs>6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hadevan.v</dc:creator>
  <cp:lastModifiedBy>mahadevan.v</cp:lastModifiedBy>
  <cp:revision>1</cp:revision>
  <dcterms:created xsi:type="dcterms:W3CDTF">2013-06-24T07:29:27Z</dcterms:created>
  <dcterms:modified xsi:type="dcterms:W3CDTF">2013-06-24T07:29:39Z</dcterms:modified>
</cp:coreProperties>
</file>